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drawings/drawing1.xml" ContentType="application/vnd.openxmlformats-officedocument.drawingml.chartshapes+xml"/>
  <Override PartName="/ppt/charts/chart2.xml" ContentType="application/vnd.openxmlformats-officedocument.drawingml.chart+xml"/>
  <Override PartName="/ppt/drawings/drawing2.xml" ContentType="application/vnd.openxmlformats-officedocument.drawingml.chartshape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0" r:id="rId2"/>
    <p:sldId id="259" r:id="rId3"/>
    <p:sldId id="258" r:id="rId4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5620"/>
    <p:restoredTop sz="94660"/>
  </p:normalViewPr>
  <p:slideViewPr>
    <p:cSldViewPr>
      <p:cViewPr varScale="1">
        <p:scale>
          <a:sx n="109" d="100"/>
          <a:sy n="109" d="100"/>
        </p:scale>
        <p:origin x="468" y="10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charts/_rels/chart1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1.xml"/><Relationship Id="rId1" Type="http://schemas.openxmlformats.org/officeDocument/2006/relationships/oleObject" Target="file:///Q:\miR-326%20ms\miR-326%20misc%20analysis\Copy%20of%20ARRB1_Exon_Intron_MIR326_TCGA_GBM_Normal_rawReadCounts.xlsx" TargetMode="External"/></Relationships>
</file>

<file path=ppt/charts/_rels/chart2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2.xml"/><Relationship Id="rId1" Type="http://schemas.openxmlformats.org/officeDocument/2006/relationships/oleObject" Target="file:///Q:\miR-326%20ms\miR-326%20misc%20analysis\Copy%20of%20ARRB1_Exon_Intron_MIR326_TCGA_GBM_Normal_rawReadCounts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 sz="1600"/>
            </a:pPr>
            <a:r>
              <a:rPr lang="en-IN" sz="1600" dirty="0" smtClean="0"/>
              <a:t>Control brain</a:t>
            </a:r>
            <a:endParaRPr lang="en-IN" sz="1600" dirty="0"/>
          </a:p>
        </c:rich>
      </c:tx>
      <c:layout>
        <c:manualLayout>
          <c:xMode val="edge"/>
          <c:yMode val="edge"/>
          <c:x val="0.36613188976377953"/>
          <c:y val="0"/>
        </c:manualLayout>
      </c:layout>
      <c:overlay val="1"/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v>Exon</c:v>
          </c:tx>
          <c:spPr>
            <a:solidFill>
              <a:srgbClr val="FF0000"/>
            </a:solidFill>
          </c:spPr>
          <c:invertIfNegative val="0"/>
          <c:errBars>
            <c:errBarType val="both"/>
            <c:errValType val="cust"/>
            <c:noEndCap val="0"/>
            <c:plus>
              <c:numRef>
                <c:f>Control!$K$2:$K$17</c:f>
                <c:numCache>
                  <c:formatCode>General</c:formatCode>
                  <c:ptCount val="16"/>
                  <c:pt idx="0">
                    <c:v>0.35936600306612798</c:v>
                  </c:pt>
                  <c:pt idx="1">
                    <c:v>1.8093870159723153</c:v>
                  </c:pt>
                  <c:pt idx="2">
                    <c:v>1.6411711132452995</c:v>
                  </c:pt>
                  <c:pt idx="3">
                    <c:v>2.0814524843110034</c:v>
                  </c:pt>
                  <c:pt idx="4">
                    <c:v>1.461530543574024</c:v>
                  </c:pt>
                  <c:pt idx="5">
                    <c:v>1.9470419158873329</c:v>
                  </c:pt>
                  <c:pt idx="6">
                    <c:v>2.0442340212324042</c:v>
                  </c:pt>
                  <c:pt idx="7">
                    <c:v>1.7084317916882747</c:v>
                  </c:pt>
                  <c:pt idx="8">
                    <c:v>1.8612790928798628</c:v>
                  </c:pt>
                  <c:pt idx="9">
                    <c:v>1.6967621191175271</c:v>
                  </c:pt>
                  <c:pt idx="10">
                    <c:v>1.5207173933588676</c:v>
                  </c:pt>
                  <c:pt idx="11">
                    <c:v>1.4969593141460493</c:v>
                  </c:pt>
                  <c:pt idx="12">
                    <c:v>2.8371604055228632</c:v>
                  </c:pt>
                  <c:pt idx="13">
                    <c:v>1.7471205091229762</c:v>
                  </c:pt>
                  <c:pt idx="14">
                    <c:v>1.6513061891053136</c:v>
                  </c:pt>
                  <c:pt idx="15">
                    <c:v>0.96300085544679481</c:v>
                  </c:pt>
                </c:numCache>
              </c:numRef>
            </c:plus>
            <c:minus>
              <c:numRef>
                <c:f>Control!$K$2:$K$17</c:f>
                <c:numCache>
                  <c:formatCode>General</c:formatCode>
                  <c:ptCount val="16"/>
                  <c:pt idx="0">
                    <c:v>0.35936600306612798</c:v>
                  </c:pt>
                  <c:pt idx="1">
                    <c:v>1.8093870159723153</c:v>
                  </c:pt>
                  <c:pt idx="2">
                    <c:v>1.6411711132452995</c:v>
                  </c:pt>
                  <c:pt idx="3">
                    <c:v>2.0814524843110034</c:v>
                  </c:pt>
                  <c:pt idx="4">
                    <c:v>1.461530543574024</c:v>
                  </c:pt>
                  <c:pt idx="5">
                    <c:v>1.9470419158873329</c:v>
                  </c:pt>
                  <c:pt idx="6">
                    <c:v>2.0442340212324042</c:v>
                  </c:pt>
                  <c:pt idx="7">
                    <c:v>1.7084317916882747</c:v>
                  </c:pt>
                  <c:pt idx="8">
                    <c:v>1.8612790928798628</c:v>
                  </c:pt>
                  <c:pt idx="9">
                    <c:v>1.6967621191175271</c:v>
                  </c:pt>
                  <c:pt idx="10">
                    <c:v>1.5207173933588676</c:v>
                  </c:pt>
                  <c:pt idx="11">
                    <c:v>1.4969593141460493</c:v>
                  </c:pt>
                  <c:pt idx="12">
                    <c:v>2.8371604055228632</c:v>
                  </c:pt>
                  <c:pt idx="13">
                    <c:v>1.7471205091229762</c:v>
                  </c:pt>
                  <c:pt idx="14">
                    <c:v>1.6513061891053136</c:v>
                  </c:pt>
                  <c:pt idx="15">
                    <c:v>0.96300085544679481</c:v>
                  </c:pt>
                </c:numCache>
              </c:numRef>
            </c:minus>
            <c:spPr>
              <a:ln>
                <a:solidFill>
                  <a:srgbClr val="FF0000"/>
                </a:solidFill>
              </a:ln>
            </c:spPr>
          </c:errBars>
          <c:cat>
            <c:numRef>
              <c:f>Control!$H$2:$H$17</c:f>
              <c:numCache>
                <c:formatCode>General</c:formatCode>
                <c:ptCount val="16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  <c:pt idx="4">
                  <c:v>5</c:v>
                </c:pt>
                <c:pt idx="5">
                  <c:v>6</c:v>
                </c:pt>
                <c:pt idx="6">
                  <c:v>7</c:v>
                </c:pt>
                <c:pt idx="7">
                  <c:v>8</c:v>
                </c:pt>
                <c:pt idx="8">
                  <c:v>9</c:v>
                </c:pt>
                <c:pt idx="9">
                  <c:v>10</c:v>
                </c:pt>
                <c:pt idx="10">
                  <c:v>11</c:v>
                </c:pt>
                <c:pt idx="11">
                  <c:v>12</c:v>
                </c:pt>
                <c:pt idx="12">
                  <c:v>13</c:v>
                </c:pt>
                <c:pt idx="13">
                  <c:v>14</c:v>
                </c:pt>
                <c:pt idx="14">
                  <c:v>15</c:v>
                </c:pt>
                <c:pt idx="15">
                  <c:v>16</c:v>
                </c:pt>
              </c:numCache>
            </c:numRef>
          </c:cat>
          <c:val>
            <c:numRef>
              <c:f>Control!$J$2:$J$17</c:f>
              <c:numCache>
                <c:formatCode>General</c:formatCode>
                <c:ptCount val="16"/>
                <c:pt idx="0">
                  <c:v>0.98983050847457632</c:v>
                </c:pt>
                <c:pt idx="1">
                  <c:v>4.9741935483870972</c:v>
                </c:pt>
                <c:pt idx="2">
                  <c:v>4.2852459016393443</c:v>
                </c:pt>
                <c:pt idx="3">
                  <c:v>5.0844444444444452</c:v>
                </c:pt>
                <c:pt idx="4">
                  <c:v>3.7939086294416251</c:v>
                </c:pt>
                <c:pt idx="5">
                  <c:v>5.3833333333333346</c:v>
                </c:pt>
                <c:pt idx="6">
                  <c:v>5.3500000000000005</c:v>
                </c:pt>
                <c:pt idx="7">
                  <c:v>4.1544117647058822</c:v>
                </c:pt>
                <c:pt idx="8">
                  <c:v>4.764705882352942</c:v>
                </c:pt>
                <c:pt idx="9">
                  <c:v>5.1890410958904116</c:v>
                </c:pt>
                <c:pt idx="10">
                  <c:v>4.4231884057971014</c:v>
                </c:pt>
                <c:pt idx="11">
                  <c:v>4.5928571428571434</c:v>
                </c:pt>
                <c:pt idx="12">
                  <c:v>8.25</c:v>
                </c:pt>
                <c:pt idx="13">
                  <c:v>5.4845070422535214</c:v>
                </c:pt>
                <c:pt idx="14">
                  <c:v>5.4730769230769232</c:v>
                </c:pt>
                <c:pt idx="15">
                  <c:v>2.5634973721930248</c:v>
                </c:pt>
              </c:numCache>
            </c:numRef>
          </c:val>
        </c:ser>
        <c:ser>
          <c:idx val="1"/>
          <c:order val="1"/>
          <c:tx>
            <c:v>Intron</c:v>
          </c:tx>
          <c:spPr>
            <a:solidFill>
              <a:schemeClr val="tx1"/>
            </a:solidFill>
          </c:spPr>
          <c:invertIfNegative val="0"/>
          <c:errBars>
            <c:errBarType val="both"/>
            <c:errValType val="cust"/>
            <c:noEndCap val="0"/>
            <c:plus>
              <c:numRef>
                <c:f>Control!$K$19:$K$33</c:f>
                <c:numCache>
                  <c:formatCode>General</c:formatCode>
                  <c:ptCount val="15"/>
                  <c:pt idx="0">
                    <c:v>3.3443231163776758E-4</c:v>
                  </c:pt>
                  <c:pt idx="1">
                    <c:v>1.4174035623909819E-2</c:v>
                  </c:pt>
                  <c:pt idx="2">
                    <c:v>1.8675969248282926E-2</c:v>
                  </c:pt>
                  <c:pt idx="3">
                    <c:v>5.3607404058955657E-2</c:v>
                  </c:pt>
                  <c:pt idx="4">
                    <c:v>3.4848123710804167E-2</c:v>
                  </c:pt>
                  <c:pt idx="5">
                    <c:v>6.9433005001796916E-2</c:v>
                  </c:pt>
                  <c:pt idx="6">
                    <c:v>2.0823192224391777E-2</c:v>
                  </c:pt>
                  <c:pt idx="7">
                    <c:v>4.5315645519998671E-2</c:v>
                  </c:pt>
                  <c:pt idx="8">
                    <c:v>0.11533531932491892</c:v>
                  </c:pt>
                  <c:pt idx="9">
                    <c:v>1.6523552586855426E-2</c:v>
                  </c:pt>
                  <c:pt idx="10">
                    <c:v>5.3182529022370896E-2</c:v>
                  </c:pt>
                  <c:pt idx="11">
                    <c:v>3.9780793174450789E-2</c:v>
                  </c:pt>
                  <c:pt idx="12">
                    <c:v>2.0653071789717242E-2</c:v>
                  </c:pt>
                  <c:pt idx="13">
                    <c:v>3.731542134453962E-2</c:v>
                  </c:pt>
                  <c:pt idx="14">
                    <c:v>4.7071485784921659E-2</c:v>
                  </c:pt>
                </c:numCache>
              </c:numRef>
            </c:plus>
            <c:minus>
              <c:numRef>
                <c:f>Control!$K$19:$K$33</c:f>
                <c:numCache>
                  <c:formatCode>General</c:formatCode>
                  <c:ptCount val="15"/>
                  <c:pt idx="0">
                    <c:v>3.3443231163776758E-4</c:v>
                  </c:pt>
                  <c:pt idx="1">
                    <c:v>1.4174035623909819E-2</c:v>
                  </c:pt>
                  <c:pt idx="2">
                    <c:v>1.8675969248282926E-2</c:v>
                  </c:pt>
                  <c:pt idx="3">
                    <c:v>5.3607404058955657E-2</c:v>
                  </c:pt>
                  <c:pt idx="4">
                    <c:v>3.4848123710804167E-2</c:v>
                  </c:pt>
                  <c:pt idx="5">
                    <c:v>6.9433005001796916E-2</c:v>
                  </c:pt>
                  <c:pt idx="6">
                    <c:v>2.0823192224391777E-2</c:v>
                  </c:pt>
                  <c:pt idx="7">
                    <c:v>4.5315645519998671E-2</c:v>
                  </c:pt>
                  <c:pt idx="8">
                    <c:v>0.11533531932491892</c:v>
                  </c:pt>
                  <c:pt idx="9">
                    <c:v>1.6523552586855426E-2</c:v>
                  </c:pt>
                  <c:pt idx="10">
                    <c:v>5.3182529022370896E-2</c:v>
                  </c:pt>
                  <c:pt idx="11">
                    <c:v>3.9780793174450789E-2</c:v>
                  </c:pt>
                  <c:pt idx="12">
                    <c:v>2.0653071789717242E-2</c:v>
                  </c:pt>
                  <c:pt idx="13">
                    <c:v>3.731542134453962E-2</c:v>
                  </c:pt>
                  <c:pt idx="14">
                    <c:v>4.7071485784921659E-2</c:v>
                  </c:pt>
                </c:numCache>
              </c:numRef>
            </c:minus>
          </c:errBars>
          <c:cat>
            <c:numRef>
              <c:f>Control!$H$2:$H$17</c:f>
              <c:numCache>
                <c:formatCode>General</c:formatCode>
                <c:ptCount val="16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  <c:pt idx="4">
                  <c:v>5</c:v>
                </c:pt>
                <c:pt idx="5">
                  <c:v>6</c:v>
                </c:pt>
                <c:pt idx="6">
                  <c:v>7</c:v>
                </c:pt>
                <c:pt idx="7">
                  <c:v>8</c:v>
                </c:pt>
                <c:pt idx="8">
                  <c:v>9</c:v>
                </c:pt>
                <c:pt idx="9">
                  <c:v>10</c:v>
                </c:pt>
                <c:pt idx="10">
                  <c:v>11</c:v>
                </c:pt>
                <c:pt idx="11">
                  <c:v>12</c:v>
                </c:pt>
                <c:pt idx="12">
                  <c:v>13</c:v>
                </c:pt>
                <c:pt idx="13">
                  <c:v>14</c:v>
                </c:pt>
                <c:pt idx="14">
                  <c:v>15</c:v>
                </c:pt>
                <c:pt idx="15">
                  <c:v>16</c:v>
                </c:pt>
              </c:numCache>
            </c:numRef>
          </c:cat>
          <c:val>
            <c:numRef>
              <c:f>Control!$J$19:$J$33</c:f>
              <c:numCache>
                <c:formatCode>General</c:formatCode>
                <c:ptCount val="15"/>
                <c:pt idx="0">
                  <c:v>2.846512534728428E-3</c:v>
                </c:pt>
                <c:pt idx="1">
                  <c:v>4.1169768325104446E-2</c:v>
                </c:pt>
                <c:pt idx="2">
                  <c:v>4.3031301482701817E-2</c:v>
                </c:pt>
                <c:pt idx="3">
                  <c:v>0.14300932090545937</c:v>
                </c:pt>
                <c:pt idx="4">
                  <c:v>0.10798418972332013</c:v>
                </c:pt>
                <c:pt idx="5">
                  <c:v>0.18705738705738706</c:v>
                </c:pt>
                <c:pt idx="6">
                  <c:v>5.1931330472103E-2</c:v>
                </c:pt>
                <c:pt idx="7">
                  <c:v>0.10362068965517242</c:v>
                </c:pt>
                <c:pt idx="8">
                  <c:v>0.33141592920353979</c:v>
                </c:pt>
                <c:pt idx="9">
                  <c:v>5.3597259231062053E-2</c:v>
                </c:pt>
                <c:pt idx="10">
                  <c:v>0.14027397260273972</c:v>
                </c:pt>
                <c:pt idx="11">
                  <c:v>0.12188034188034187</c:v>
                </c:pt>
                <c:pt idx="12">
                  <c:v>6.8296242247354977E-2</c:v>
                </c:pt>
                <c:pt idx="13">
                  <c:v>0.13282700421940929</c:v>
                </c:pt>
                <c:pt idx="14">
                  <c:v>0.17545388525780684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46706752"/>
        <c:axId val="149223768"/>
      </c:barChart>
      <c:catAx>
        <c:axId val="146706752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b="1"/>
            </a:pPr>
            <a:endParaRPr lang="en-US"/>
          </a:p>
        </c:txPr>
        <c:crossAx val="149223768"/>
        <c:crosses val="autoZero"/>
        <c:auto val="1"/>
        <c:lblAlgn val="ctr"/>
        <c:lblOffset val="100"/>
        <c:noMultiLvlLbl val="0"/>
      </c:catAx>
      <c:valAx>
        <c:axId val="149223768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sz="1200" b="0"/>
                </a:pPr>
                <a:r>
                  <a:rPr lang="en-IN" sz="1200" b="0" dirty="0" smtClean="0"/>
                  <a:t>Normalised read</a:t>
                </a:r>
                <a:r>
                  <a:rPr lang="en-IN" sz="1200" b="0" baseline="0" dirty="0" smtClean="0"/>
                  <a:t> count</a:t>
                </a:r>
                <a:endParaRPr lang="en-IN" sz="1200" b="0" dirty="0"/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b="1"/>
            </a:pPr>
            <a:endParaRPr lang="en-US"/>
          </a:p>
        </c:txPr>
        <c:crossAx val="146706752"/>
        <c:crosses val="autoZero"/>
        <c:crossBetween val="between"/>
      </c:valAx>
    </c:plotArea>
    <c:legend>
      <c:legendPos val="b"/>
      <c:layout/>
      <c:overlay val="0"/>
    </c:legend>
    <c:plotVisOnly val="1"/>
    <c:dispBlanksAs val="gap"/>
    <c:showDLblsOverMax val="0"/>
  </c:chart>
  <c:txPr>
    <a:bodyPr/>
    <a:lstStyle/>
    <a:p>
      <a:pPr>
        <a:defRPr>
          <a:latin typeface="Times New Roman" pitchFamily="18" charset="0"/>
          <a:cs typeface="Times New Roman" pitchFamily="18" charset="0"/>
        </a:defRPr>
      </a:pPr>
      <a:endParaRPr lang="en-US"/>
    </a:p>
  </c:txPr>
  <c:externalData r:id="rId1">
    <c:autoUpdate val="0"/>
  </c:externalData>
  <c:userShapes r:id="rId2"/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 sz="1600"/>
            </a:pPr>
            <a:r>
              <a:rPr lang="en-IN" sz="1600"/>
              <a:t>GBM</a:t>
            </a:r>
          </a:p>
        </c:rich>
      </c:tx>
      <c:layout>
        <c:manualLayout>
          <c:xMode val="edge"/>
          <c:yMode val="edge"/>
          <c:x val="0.43581255468066493"/>
          <c:y val="0"/>
        </c:manualLayout>
      </c:layout>
      <c:overlay val="1"/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v>Exon</c:v>
          </c:tx>
          <c:spPr>
            <a:solidFill>
              <a:srgbClr val="FF0000"/>
            </a:solidFill>
          </c:spPr>
          <c:invertIfNegative val="0"/>
          <c:errBars>
            <c:errBarType val="both"/>
            <c:errValType val="cust"/>
            <c:noEndCap val="0"/>
            <c:plus>
              <c:numRef>
                <c:f>GBM!$G$2:$G$17</c:f>
                <c:numCache>
                  <c:formatCode>General</c:formatCode>
                  <c:ptCount val="16"/>
                  <c:pt idx="0">
                    <c:v>7.9430728499687797E-2</c:v>
                  </c:pt>
                  <c:pt idx="1">
                    <c:v>0.71612628836310444</c:v>
                  </c:pt>
                  <c:pt idx="2">
                    <c:v>0.57065799398505246</c:v>
                  </c:pt>
                  <c:pt idx="3">
                    <c:v>0.69955491179251494</c:v>
                  </c:pt>
                  <c:pt idx="4">
                    <c:v>0.39005605056285758</c:v>
                  </c:pt>
                  <c:pt idx="5">
                    <c:v>0.63451294990013885</c:v>
                  </c:pt>
                  <c:pt idx="6">
                    <c:v>0.64965409805975605</c:v>
                  </c:pt>
                  <c:pt idx="7">
                    <c:v>0.50636593828394083</c:v>
                  </c:pt>
                  <c:pt idx="8">
                    <c:v>0.65510184724359488</c:v>
                  </c:pt>
                  <c:pt idx="9">
                    <c:v>0.79846031729610201</c:v>
                  </c:pt>
                  <c:pt idx="10">
                    <c:v>0.58199042192184214</c:v>
                  </c:pt>
                  <c:pt idx="11">
                    <c:v>0.64354292920463663</c:v>
                  </c:pt>
                  <c:pt idx="12">
                    <c:v>1.253484907305862</c:v>
                  </c:pt>
                  <c:pt idx="13">
                    <c:v>0.7805614115884838</c:v>
                  </c:pt>
                  <c:pt idx="14">
                    <c:v>0.98211454731712111</c:v>
                  </c:pt>
                  <c:pt idx="15">
                    <c:v>0.22505816449295418</c:v>
                  </c:pt>
                </c:numCache>
              </c:numRef>
            </c:plus>
            <c:minus>
              <c:numRef>
                <c:f>GBM!$G$2:$G$17</c:f>
                <c:numCache>
                  <c:formatCode>General</c:formatCode>
                  <c:ptCount val="16"/>
                  <c:pt idx="0">
                    <c:v>7.9430728499687797E-2</c:v>
                  </c:pt>
                  <c:pt idx="1">
                    <c:v>0.71612628836310444</c:v>
                  </c:pt>
                  <c:pt idx="2">
                    <c:v>0.57065799398505246</c:v>
                  </c:pt>
                  <c:pt idx="3">
                    <c:v>0.69955491179251494</c:v>
                  </c:pt>
                  <c:pt idx="4">
                    <c:v>0.39005605056285758</c:v>
                  </c:pt>
                  <c:pt idx="5">
                    <c:v>0.63451294990013885</c:v>
                  </c:pt>
                  <c:pt idx="6">
                    <c:v>0.64965409805975605</c:v>
                  </c:pt>
                  <c:pt idx="7">
                    <c:v>0.50636593828394083</c:v>
                  </c:pt>
                  <c:pt idx="8">
                    <c:v>0.65510184724359488</c:v>
                  </c:pt>
                  <c:pt idx="9">
                    <c:v>0.79846031729610201</c:v>
                  </c:pt>
                  <c:pt idx="10">
                    <c:v>0.58199042192184214</c:v>
                  </c:pt>
                  <c:pt idx="11">
                    <c:v>0.64354292920463663</c:v>
                  </c:pt>
                  <c:pt idx="12">
                    <c:v>1.253484907305862</c:v>
                  </c:pt>
                  <c:pt idx="13">
                    <c:v>0.7805614115884838</c:v>
                  </c:pt>
                  <c:pt idx="14">
                    <c:v>0.98211454731712111</c:v>
                  </c:pt>
                  <c:pt idx="15">
                    <c:v>0.22505816449295418</c:v>
                  </c:pt>
                </c:numCache>
              </c:numRef>
            </c:minus>
            <c:spPr>
              <a:ln>
                <a:solidFill>
                  <a:srgbClr val="FF0000"/>
                </a:solidFill>
              </a:ln>
            </c:spPr>
          </c:errBars>
          <c:val>
            <c:numRef>
              <c:f>GBM!$F$2:$F$17</c:f>
              <c:numCache>
                <c:formatCode>General</c:formatCode>
                <c:ptCount val="16"/>
                <c:pt idx="0">
                  <c:v>8.302039987820975E-2</c:v>
                </c:pt>
                <c:pt idx="1">
                  <c:v>0.99981245311327815</c:v>
                </c:pt>
                <c:pt idx="2">
                  <c:v>0.82119710255432721</c:v>
                </c:pt>
                <c:pt idx="3">
                  <c:v>1.0069767441860464</c:v>
                </c:pt>
                <c:pt idx="4">
                  <c:v>0.5639534883720928</c:v>
                </c:pt>
                <c:pt idx="5">
                  <c:v>0.91027131782945714</c:v>
                </c:pt>
                <c:pt idx="6">
                  <c:v>0.9336525307797533</c:v>
                </c:pt>
                <c:pt idx="7">
                  <c:v>0.73683310533515689</c:v>
                </c:pt>
                <c:pt idx="8">
                  <c:v>1.0010943912448695</c:v>
                </c:pt>
                <c:pt idx="9">
                  <c:v>1.264176489327812</c:v>
                </c:pt>
                <c:pt idx="10">
                  <c:v>0.92429221435793751</c:v>
                </c:pt>
                <c:pt idx="11">
                  <c:v>0.97473698781838314</c:v>
                </c:pt>
                <c:pt idx="12">
                  <c:v>1.7541182170542637</c:v>
                </c:pt>
                <c:pt idx="13">
                  <c:v>1.1754831313462171</c:v>
                </c:pt>
                <c:pt idx="14">
                  <c:v>1.5495304114490158</c:v>
                </c:pt>
                <c:pt idx="15">
                  <c:v>0.32592028800320011</c:v>
                </c:pt>
              </c:numCache>
            </c:numRef>
          </c:val>
        </c:ser>
        <c:ser>
          <c:idx val="1"/>
          <c:order val="1"/>
          <c:tx>
            <c:v>Intron</c:v>
          </c:tx>
          <c:spPr>
            <a:solidFill>
              <a:schemeClr val="tx1"/>
            </a:solidFill>
          </c:spPr>
          <c:invertIfNegative val="0"/>
          <c:errBars>
            <c:errBarType val="both"/>
            <c:errValType val="cust"/>
            <c:noEndCap val="0"/>
            <c:plus>
              <c:numRef>
                <c:f>GBM!$G$19:$G$33</c:f>
                <c:numCache>
                  <c:formatCode>General</c:formatCode>
                  <c:ptCount val="15"/>
                  <c:pt idx="0">
                    <c:v>9.3545358070098626E-4</c:v>
                  </c:pt>
                  <c:pt idx="1">
                    <c:v>7.1435481678956249E-3</c:v>
                  </c:pt>
                  <c:pt idx="2">
                    <c:v>7.8450317393836972E-3</c:v>
                  </c:pt>
                  <c:pt idx="3">
                    <c:v>2.5360996705090566E-2</c:v>
                  </c:pt>
                  <c:pt idx="4">
                    <c:v>1.8830948236631333E-2</c:v>
                  </c:pt>
                  <c:pt idx="5">
                    <c:v>2.5150737497761259E-2</c:v>
                  </c:pt>
                  <c:pt idx="6">
                    <c:v>1.1310303565474245E-2</c:v>
                  </c:pt>
                  <c:pt idx="7">
                    <c:v>2.1241057660852183E-2</c:v>
                  </c:pt>
                  <c:pt idx="8">
                    <c:v>6.4844827018358461E-2</c:v>
                  </c:pt>
                  <c:pt idx="9">
                    <c:v>1.2311142898114016E-2</c:v>
                  </c:pt>
                  <c:pt idx="10">
                    <c:v>2.3543887700860994E-2</c:v>
                  </c:pt>
                  <c:pt idx="11">
                    <c:v>2.2519800691419931E-2</c:v>
                  </c:pt>
                  <c:pt idx="12">
                    <c:v>1.1112247199187717E-2</c:v>
                  </c:pt>
                  <c:pt idx="13">
                    <c:v>2.6213763963146976E-2</c:v>
                  </c:pt>
                  <c:pt idx="14">
                    <c:v>3.8143188143172198E-2</c:v>
                  </c:pt>
                </c:numCache>
              </c:numRef>
            </c:plus>
            <c:minus>
              <c:numRef>
                <c:f>GBM!$G$19:$G$33</c:f>
                <c:numCache>
                  <c:formatCode>General</c:formatCode>
                  <c:ptCount val="15"/>
                  <c:pt idx="0">
                    <c:v>9.3545358070098626E-4</c:v>
                  </c:pt>
                  <c:pt idx="1">
                    <c:v>7.1435481678956249E-3</c:v>
                  </c:pt>
                  <c:pt idx="2">
                    <c:v>7.8450317393836972E-3</c:v>
                  </c:pt>
                  <c:pt idx="3">
                    <c:v>2.5360996705090566E-2</c:v>
                  </c:pt>
                  <c:pt idx="4">
                    <c:v>1.8830948236631333E-2</c:v>
                  </c:pt>
                  <c:pt idx="5">
                    <c:v>2.5150737497761259E-2</c:v>
                  </c:pt>
                  <c:pt idx="6">
                    <c:v>1.1310303565474245E-2</c:v>
                  </c:pt>
                  <c:pt idx="7">
                    <c:v>2.1241057660852183E-2</c:v>
                  </c:pt>
                  <c:pt idx="8">
                    <c:v>6.4844827018358461E-2</c:v>
                  </c:pt>
                  <c:pt idx="9">
                    <c:v>1.2311142898114016E-2</c:v>
                  </c:pt>
                  <c:pt idx="10">
                    <c:v>2.3543887700860994E-2</c:v>
                  </c:pt>
                  <c:pt idx="11">
                    <c:v>2.2519800691419931E-2</c:v>
                  </c:pt>
                  <c:pt idx="12">
                    <c:v>1.1112247199187717E-2</c:v>
                  </c:pt>
                  <c:pt idx="13">
                    <c:v>2.6213763963146976E-2</c:v>
                  </c:pt>
                  <c:pt idx="14">
                    <c:v>3.8143188143172198E-2</c:v>
                  </c:pt>
                </c:numCache>
              </c:numRef>
            </c:minus>
            <c:spPr>
              <a:ln>
                <a:solidFill>
                  <a:schemeClr val="tx1"/>
                </a:solidFill>
              </a:ln>
            </c:spPr>
          </c:errBars>
          <c:val>
            <c:numRef>
              <c:f>GBM!$F$19:$F$33</c:f>
              <c:numCache>
                <c:formatCode>General</c:formatCode>
                <c:ptCount val="15"/>
                <c:pt idx="0">
                  <c:v>9.6623714816744641E-4</c:v>
                </c:pt>
                <c:pt idx="1">
                  <c:v>9.9872812867098336E-3</c:v>
                </c:pt>
                <c:pt idx="2">
                  <c:v>1.2187272518294316E-2</c:v>
                </c:pt>
                <c:pt idx="3">
                  <c:v>3.5270801721735363E-2</c:v>
                </c:pt>
                <c:pt idx="4">
                  <c:v>2.6316757054876346E-2</c:v>
                </c:pt>
                <c:pt idx="5">
                  <c:v>3.5643297271204182E-2</c:v>
                </c:pt>
                <c:pt idx="6">
                  <c:v>1.6201716738197425E-2</c:v>
                </c:pt>
                <c:pt idx="7">
                  <c:v>3.0668604651162772E-2</c:v>
                </c:pt>
                <c:pt idx="8">
                  <c:v>0.10076661864581186</c:v>
                </c:pt>
                <c:pt idx="9">
                  <c:v>1.9404927364311583E-2</c:v>
                </c:pt>
                <c:pt idx="10">
                  <c:v>3.6970372730168816E-2</c:v>
                </c:pt>
                <c:pt idx="11">
                  <c:v>3.2091035579407602E-2</c:v>
                </c:pt>
                <c:pt idx="12">
                  <c:v>1.5554075494429966E-2</c:v>
                </c:pt>
                <c:pt idx="13">
                  <c:v>4.0413109606515542E-2</c:v>
                </c:pt>
                <c:pt idx="14">
                  <c:v>5.1620475925081476E-2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51942816"/>
        <c:axId val="152659736"/>
      </c:barChart>
      <c:catAx>
        <c:axId val="151942816"/>
        <c:scaling>
          <c:orientation val="minMax"/>
        </c:scaling>
        <c:delete val="0"/>
        <c:axPos val="b"/>
        <c:majorTickMark val="out"/>
        <c:minorTickMark val="none"/>
        <c:tickLblPos val="nextTo"/>
        <c:txPr>
          <a:bodyPr/>
          <a:lstStyle/>
          <a:p>
            <a:pPr>
              <a:defRPr b="1"/>
            </a:pPr>
            <a:endParaRPr lang="en-US"/>
          </a:p>
        </c:txPr>
        <c:crossAx val="152659736"/>
        <c:crosses val="autoZero"/>
        <c:auto val="1"/>
        <c:lblAlgn val="ctr"/>
        <c:lblOffset val="100"/>
        <c:noMultiLvlLbl val="0"/>
      </c:catAx>
      <c:valAx>
        <c:axId val="152659736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sz="1200" b="0"/>
                </a:pPr>
                <a:r>
                  <a:rPr lang="en-IN" sz="1200" b="0" dirty="0" smtClean="0"/>
                  <a:t>Normalised read count</a:t>
                </a:r>
                <a:endParaRPr lang="en-IN" sz="1200" b="0" dirty="0"/>
              </a:p>
            </c:rich>
          </c:tx>
          <c:layout>
            <c:manualLayout>
              <c:xMode val="edge"/>
              <c:yMode val="edge"/>
              <c:x val="2.2222222222222223E-2"/>
              <c:y val="0.16025627004957713"/>
            </c:manualLayout>
          </c:layout>
          <c:overlay val="0"/>
        </c:title>
        <c:numFmt formatCode="#,##0.0" sourceLinked="0"/>
        <c:majorTickMark val="out"/>
        <c:minorTickMark val="none"/>
        <c:tickLblPos val="nextTo"/>
        <c:txPr>
          <a:bodyPr/>
          <a:lstStyle/>
          <a:p>
            <a:pPr>
              <a:defRPr b="1"/>
            </a:pPr>
            <a:endParaRPr lang="en-US"/>
          </a:p>
        </c:txPr>
        <c:crossAx val="151942816"/>
        <c:crosses val="autoZero"/>
        <c:crossBetween val="between"/>
      </c:valAx>
    </c:plotArea>
    <c:legend>
      <c:legendPos val="b"/>
      <c:layout/>
      <c:overlay val="0"/>
    </c:legend>
    <c:plotVisOnly val="1"/>
    <c:dispBlanksAs val="gap"/>
    <c:showDLblsOverMax val="0"/>
  </c:chart>
  <c:txPr>
    <a:bodyPr/>
    <a:lstStyle/>
    <a:p>
      <a:pPr>
        <a:defRPr>
          <a:latin typeface="Times New Roman" pitchFamily="18" charset="0"/>
          <a:cs typeface="Times New Roman" pitchFamily="18" charset="0"/>
        </a:defRPr>
      </a:pPr>
      <a:endParaRPr lang="en-US"/>
    </a:p>
  </c:txPr>
  <c:externalData r:id="rId1">
    <c:autoUpdate val="0"/>
  </c:externalData>
  <c:userShapes r:id="rId2"/>
</c:chartSpac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13091</cdr:x>
      <cdr:y>0.6</cdr:y>
    </cdr:from>
    <cdr:to>
      <cdr:x>0.20183</cdr:x>
      <cdr:y>0.68333</cdr:y>
    </cdr:to>
    <cdr:sp macro="" textlink="">
      <cdr:nvSpPr>
        <cdr:cNvPr id="3" name="TextBox 2"/>
        <cdr:cNvSpPr txBox="1"/>
      </cdr:nvSpPr>
      <cdr:spPr>
        <a:xfrm xmlns:a="http://schemas.openxmlformats.org/drawingml/2006/main">
          <a:off x="562610" y="1645920"/>
          <a:ext cx="304800" cy="22860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r>
            <a:rPr lang="en-US" sz="1000" dirty="0" smtClean="0">
              <a:latin typeface="Times New Roman" pitchFamily="18" charset="0"/>
              <a:cs typeface="Times New Roman" pitchFamily="18" charset="0"/>
            </a:rPr>
            <a:t>**</a:t>
          </a:r>
          <a:endParaRPr lang="en-IN" sz="1000" dirty="0">
            <a:latin typeface="Times New Roman" pitchFamily="18" charset="0"/>
            <a:cs typeface="Times New Roman" pitchFamily="18" charset="0"/>
          </a:endParaRPr>
        </a:p>
      </cdr:txBody>
    </cdr:sp>
  </cdr:relSizeAnchor>
</c:userShapes>
</file>

<file path=ppt/drawings/drawing2.xml><?xml version="1.0" encoding="utf-8"?>
<c:userShapes xmlns:c="http://schemas.openxmlformats.org/drawingml/2006/chart">
  <cdr:relSizeAnchor xmlns:cdr="http://schemas.openxmlformats.org/drawingml/2006/chartDrawing">
    <cdr:from>
      <cdr:x>0.13155</cdr:x>
      <cdr:y>0.61944</cdr:y>
    </cdr:from>
    <cdr:to>
      <cdr:x>0.2202</cdr:x>
      <cdr:y>0.70278</cdr:y>
    </cdr:to>
    <cdr:sp macro="" textlink="">
      <cdr:nvSpPr>
        <cdr:cNvPr id="2" name="TextBox 1"/>
        <cdr:cNvSpPr txBox="1"/>
      </cdr:nvSpPr>
      <cdr:spPr>
        <a:xfrm xmlns:a="http://schemas.openxmlformats.org/drawingml/2006/main">
          <a:off x="565358" y="1699260"/>
          <a:ext cx="381000" cy="22860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r>
            <a:rPr lang="en-US" sz="1000" dirty="0" smtClean="0">
              <a:latin typeface="Times New Roman" pitchFamily="18" charset="0"/>
              <a:cs typeface="Times New Roman" pitchFamily="18" charset="0"/>
            </a:rPr>
            <a:t>***</a:t>
          </a:r>
          <a:endParaRPr lang="en-IN" sz="1000" dirty="0">
            <a:latin typeface="Times New Roman" pitchFamily="18" charset="0"/>
            <a:cs typeface="Times New Roman" pitchFamily="18" charset="0"/>
          </a:endParaRPr>
        </a:p>
      </cdr:txBody>
    </cdr:sp>
  </cdr:relSizeAnchor>
</c:userShap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46174F-2BE4-4356-8A49-F50814BACB04}" type="datetimeFigureOut">
              <a:rPr lang="en-IN" smtClean="0"/>
              <a:t>16-11-2016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DD23A5-7F99-4394-ABAC-A332411BD19C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02955145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46174F-2BE4-4356-8A49-F50814BACB04}" type="datetimeFigureOut">
              <a:rPr lang="en-IN" smtClean="0"/>
              <a:t>16-11-2016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DD23A5-7F99-4394-ABAC-A332411BD19C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4099081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46174F-2BE4-4356-8A49-F50814BACB04}" type="datetimeFigureOut">
              <a:rPr lang="en-IN" smtClean="0"/>
              <a:t>16-11-2016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DD23A5-7F99-4394-ABAC-A332411BD19C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72310859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46174F-2BE4-4356-8A49-F50814BACB04}" type="datetimeFigureOut">
              <a:rPr lang="en-IN" smtClean="0"/>
              <a:t>16-11-2016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DD23A5-7F99-4394-ABAC-A332411BD19C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59393489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46174F-2BE4-4356-8A49-F50814BACB04}" type="datetimeFigureOut">
              <a:rPr lang="en-IN" smtClean="0"/>
              <a:t>16-11-2016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DD23A5-7F99-4394-ABAC-A332411BD19C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69844884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46174F-2BE4-4356-8A49-F50814BACB04}" type="datetimeFigureOut">
              <a:rPr lang="en-IN" smtClean="0"/>
              <a:t>16-11-2016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DD23A5-7F99-4394-ABAC-A332411BD19C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417772851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46174F-2BE4-4356-8A49-F50814BACB04}" type="datetimeFigureOut">
              <a:rPr lang="en-IN" smtClean="0"/>
              <a:t>16-11-2016</a:t>
            </a:fld>
            <a:endParaRPr lang="en-IN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DD23A5-7F99-4394-ABAC-A332411BD19C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31697114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46174F-2BE4-4356-8A49-F50814BACB04}" type="datetimeFigureOut">
              <a:rPr lang="en-IN" smtClean="0"/>
              <a:t>16-11-2016</a:t>
            </a:fld>
            <a:endParaRPr lang="en-IN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DD23A5-7F99-4394-ABAC-A332411BD19C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06403380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46174F-2BE4-4356-8A49-F50814BACB04}" type="datetimeFigureOut">
              <a:rPr lang="en-IN" smtClean="0"/>
              <a:t>16-11-2016</a:t>
            </a:fld>
            <a:endParaRPr lang="en-IN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DD23A5-7F99-4394-ABAC-A332411BD19C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14174985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46174F-2BE4-4356-8A49-F50814BACB04}" type="datetimeFigureOut">
              <a:rPr lang="en-IN" smtClean="0"/>
              <a:t>16-11-2016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DD23A5-7F99-4394-ABAC-A332411BD19C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34287939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IN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46174F-2BE4-4356-8A49-F50814BACB04}" type="datetimeFigureOut">
              <a:rPr lang="en-IN" smtClean="0"/>
              <a:t>16-11-2016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DD23A5-7F99-4394-ABAC-A332411BD19C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6575143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D46174F-2BE4-4356-8A49-F50814BACB04}" type="datetimeFigureOut">
              <a:rPr lang="en-IN" smtClean="0"/>
              <a:t>16-11-2016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FDD23A5-7F99-4394-ABAC-A332411BD19C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54532062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Relationship Id="rId4" Type="http://schemas.openxmlformats.org/officeDocument/2006/relationships/chart" Target="../charts/chart2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b="1" dirty="0"/>
              <a:t>Supplementary Informatio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>
            <a:normAutofit fontScale="55000" lnSpcReduction="20000"/>
          </a:bodyPr>
          <a:lstStyle/>
          <a:p>
            <a:pPr marL="0" indent="0">
              <a:buNone/>
            </a:pPr>
            <a:r>
              <a:rPr lang="en-US" b="1" dirty="0"/>
              <a:t>Supplementary figure legends</a:t>
            </a:r>
            <a:endParaRPr lang="en-US" dirty="0"/>
          </a:p>
          <a:p>
            <a:pPr marL="0" indent="0">
              <a:buNone/>
            </a:pPr>
            <a:r>
              <a:rPr lang="en-US" b="1" dirty="0"/>
              <a:t> </a:t>
            </a:r>
            <a:endParaRPr lang="en-US" dirty="0"/>
          </a:p>
          <a:p>
            <a:pPr marL="0" indent="0">
              <a:buNone/>
            </a:pPr>
            <a:r>
              <a:rPr lang="en-US" b="1" dirty="0"/>
              <a:t>Figure S1, miR-326 and ARRB1 share a common promoter upstream to ARRB1. a, b, </a:t>
            </a:r>
            <a:r>
              <a:rPr lang="en-US" dirty="0"/>
              <a:t>Normalized read count of the exons and introns of ARRB1 gene, derived from the RNA-</a:t>
            </a:r>
            <a:r>
              <a:rPr lang="en-US" dirty="0" err="1"/>
              <a:t>seq</a:t>
            </a:r>
            <a:r>
              <a:rPr lang="en-US" dirty="0"/>
              <a:t> data from TCGA in control brain </a:t>
            </a:r>
            <a:r>
              <a:rPr lang="en-US" b="1" dirty="0"/>
              <a:t>(a) </a:t>
            </a:r>
            <a:r>
              <a:rPr lang="en-US" dirty="0"/>
              <a:t>and GBM </a:t>
            </a:r>
            <a:r>
              <a:rPr lang="en-US" b="1" dirty="0"/>
              <a:t>(b)</a:t>
            </a:r>
            <a:r>
              <a:rPr lang="en-US" dirty="0"/>
              <a:t>. The exons are denoted by red bars, while as the introns which get spliced out and degrade soon are denoted by black </a:t>
            </a:r>
            <a:r>
              <a:rPr lang="en-US" dirty="0" smtClean="0"/>
              <a:t>bars. For </a:t>
            </a:r>
            <a:r>
              <a:rPr lang="en-US" dirty="0"/>
              <a:t>each exon or intron, the read counts were calculated from multiple samples (control brain, n=5 and GBM, n=172). Standard deviation for each exon/intron is plotted and </a:t>
            </a:r>
            <a:r>
              <a:rPr lang="en-US" i="1" dirty="0"/>
              <a:t>p </a:t>
            </a:r>
            <a:r>
              <a:rPr lang="en-US" dirty="0"/>
              <a:t>values were calculated by student’s t-test and the symbols are indicated. (**) p ≤ 0.01; </a:t>
            </a:r>
            <a:r>
              <a:rPr lang="en-US" dirty="0" smtClean="0"/>
              <a:t>(***) p≤0.001.</a:t>
            </a:r>
          </a:p>
          <a:p>
            <a:pPr marL="0" indent="0">
              <a:buNone/>
            </a:pPr>
            <a:r>
              <a:rPr lang="en-US" b="1" dirty="0" smtClean="0"/>
              <a:t>c</a:t>
            </a:r>
            <a:r>
              <a:rPr lang="en-US" b="1" dirty="0"/>
              <a:t>, </a:t>
            </a:r>
            <a:r>
              <a:rPr lang="en-US" dirty="0"/>
              <a:t>Histone profile for the entire ARRB1 gene encompassing miR-326 in its first intron. The different rows indicate the histone marks derived from 7 cell lines from the ENCODE project. The histone marks depicted include </a:t>
            </a:r>
            <a:r>
              <a:rPr lang="en-US" dirty="0" err="1"/>
              <a:t>overlayed</a:t>
            </a:r>
            <a:r>
              <a:rPr lang="en-US" dirty="0"/>
              <a:t> H3K4Me1, H3K27Ac and H3K4Me3 marks. While H3K4Me1 and H3K27Ac mark is suggestive of regulatory elements like enhancers, H3K4Me3 mark is found in promoter regulatory elements.</a:t>
            </a:r>
          </a:p>
          <a:p>
            <a:pPr marL="0" indent="0">
              <a:buNone/>
            </a:pPr>
            <a:r>
              <a:rPr lang="en-US" b="1" dirty="0"/>
              <a:t>  </a:t>
            </a:r>
            <a:endParaRPr lang="en-US" dirty="0"/>
          </a:p>
          <a:p>
            <a:pPr marL="0" indent="0">
              <a:buNone/>
            </a:pPr>
            <a:r>
              <a:rPr lang="en-US" b="1" dirty="0"/>
              <a:t>Figure S2, Flowchart for the shortlisting of transcription factors regulated by the PI3 kinase pathway.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05454734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Box 6"/>
          <p:cNvSpPr txBox="1"/>
          <p:nvPr/>
        </p:nvSpPr>
        <p:spPr>
          <a:xfrm>
            <a:off x="7463732" y="-16217"/>
            <a:ext cx="168026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Supplementary figure 1 </a:t>
            </a:r>
            <a:endParaRPr lang="en-IN" sz="12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8" name="TextBox 17"/>
          <p:cNvSpPr txBox="1"/>
          <p:nvPr/>
        </p:nvSpPr>
        <p:spPr>
          <a:xfrm>
            <a:off x="454796" y="142032"/>
            <a:ext cx="29527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Times New Roman" pitchFamily="18" charset="0"/>
                <a:cs typeface="Times New Roman" pitchFamily="18" charset="0"/>
              </a:rPr>
              <a:t>a</a:t>
            </a:r>
            <a:endParaRPr lang="en-IN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9" name="TextBox 18"/>
          <p:cNvSpPr txBox="1"/>
          <p:nvPr/>
        </p:nvSpPr>
        <p:spPr>
          <a:xfrm>
            <a:off x="4761190" y="142032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Times New Roman" pitchFamily="18" charset="0"/>
                <a:cs typeface="Times New Roman" pitchFamily="18" charset="0"/>
              </a:rPr>
              <a:t>b</a:t>
            </a:r>
            <a:endParaRPr lang="en-IN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0" name="TextBox 19"/>
          <p:cNvSpPr txBox="1"/>
          <p:nvPr/>
        </p:nvSpPr>
        <p:spPr>
          <a:xfrm>
            <a:off x="454796" y="3175188"/>
            <a:ext cx="28725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Times New Roman" pitchFamily="18" charset="0"/>
                <a:cs typeface="Times New Roman" pitchFamily="18" charset="0"/>
              </a:rPr>
              <a:t>c</a:t>
            </a:r>
            <a:endParaRPr lang="en-IN" dirty="0">
              <a:latin typeface="Times New Roman" pitchFamily="18" charset="0"/>
              <a:cs typeface="Times New Roman" pitchFamily="18" charset="0"/>
            </a:endParaRPr>
          </a:p>
        </p:txBody>
      </p:sp>
      <p:grpSp>
        <p:nvGrpSpPr>
          <p:cNvPr id="17" name="Group 16"/>
          <p:cNvGrpSpPr/>
          <p:nvPr/>
        </p:nvGrpSpPr>
        <p:grpSpPr>
          <a:xfrm>
            <a:off x="533400" y="3655833"/>
            <a:ext cx="8229600" cy="2440167"/>
            <a:chOff x="400336" y="533400"/>
            <a:chExt cx="8229600" cy="2440167"/>
          </a:xfrm>
        </p:grpSpPr>
        <p:pic>
          <p:nvPicPr>
            <p:cNvPr id="27" name="Picture 2" descr="C:\Users\Nawazahid\Desktop\arrb1 histone profile.jpg"/>
            <p:cNvPicPr preferRelativeResize="0">
              <a:picLocks noChangeAspect="1"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00336" y="533400"/>
              <a:ext cx="8229600" cy="205740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28" name="Left Brace 27"/>
            <p:cNvSpPr/>
            <p:nvPr/>
          </p:nvSpPr>
          <p:spPr>
            <a:xfrm rot="16200000">
              <a:off x="7827944" y="2475414"/>
              <a:ext cx="100818" cy="384048"/>
            </a:xfrm>
            <a:prstGeom prst="leftBrac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IN"/>
            </a:p>
          </p:txBody>
        </p:sp>
        <p:sp>
          <p:nvSpPr>
            <p:cNvPr id="29" name="TextBox 28"/>
            <p:cNvSpPr txBox="1"/>
            <p:nvPr/>
          </p:nvSpPr>
          <p:spPr>
            <a:xfrm>
              <a:off x="7649684" y="2696568"/>
              <a:ext cx="47000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200" b="1" dirty="0" smtClean="0">
                  <a:latin typeface="Times New Roman" pitchFamily="18" charset="0"/>
                  <a:cs typeface="Times New Roman" pitchFamily="18" charset="0"/>
                </a:rPr>
                <a:t>6 kb</a:t>
              </a:r>
              <a:endParaRPr lang="en-IN" sz="1200" b="1" dirty="0">
                <a:latin typeface="Times New Roman" pitchFamily="18" charset="0"/>
                <a:cs typeface="Times New Roman" pitchFamily="18" charset="0"/>
              </a:endParaRPr>
            </a:p>
          </p:txBody>
        </p:sp>
      </p:grpSp>
      <p:grpSp>
        <p:nvGrpSpPr>
          <p:cNvPr id="4" name="Group 3"/>
          <p:cNvGrpSpPr/>
          <p:nvPr/>
        </p:nvGrpSpPr>
        <p:grpSpPr>
          <a:xfrm>
            <a:off x="278421" y="457200"/>
            <a:ext cx="4369779" cy="2743200"/>
            <a:chOff x="278421" y="457200"/>
            <a:chExt cx="4369779" cy="2743200"/>
          </a:xfrm>
        </p:grpSpPr>
        <p:grpSp>
          <p:nvGrpSpPr>
            <p:cNvPr id="25" name="Group 24"/>
            <p:cNvGrpSpPr/>
            <p:nvPr/>
          </p:nvGrpSpPr>
          <p:grpSpPr>
            <a:xfrm>
              <a:off x="350520" y="457200"/>
              <a:ext cx="4297680" cy="2743200"/>
              <a:chOff x="381000" y="457200"/>
              <a:chExt cx="4297680" cy="2743200"/>
            </a:xfrm>
          </p:grpSpPr>
          <p:graphicFrame>
            <p:nvGraphicFramePr>
              <p:cNvPr id="5" name="Chart 4"/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2777093819"/>
                  </p:ext>
                </p:extLst>
              </p:nvPr>
            </p:nvGraphicFramePr>
            <p:xfrm>
              <a:off x="381000" y="457200"/>
              <a:ext cx="4297680" cy="2743200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3"/>
              </a:graphicData>
            </a:graphic>
          </p:graphicFrame>
          <p:sp>
            <p:nvSpPr>
              <p:cNvPr id="23" name="Left Bracket 22"/>
              <p:cNvSpPr/>
              <p:nvPr/>
            </p:nvSpPr>
            <p:spPr>
              <a:xfrm rot="5400000">
                <a:off x="1073150" y="2240280"/>
                <a:ext cx="45720" cy="137160"/>
              </a:xfrm>
              <a:prstGeom prst="leftBracket">
                <a:avLst/>
              </a:prstGeom>
              <a:ln>
                <a:solidFill>
                  <a:schemeClr val="accent3">
                    <a:lumMod val="50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IN"/>
              </a:p>
            </p:txBody>
          </p:sp>
        </p:grpSp>
        <p:sp>
          <p:nvSpPr>
            <p:cNvPr id="2" name="TextBox 1"/>
            <p:cNvSpPr txBox="1"/>
            <p:nvPr/>
          </p:nvSpPr>
          <p:spPr>
            <a:xfrm>
              <a:off x="278421" y="2563504"/>
              <a:ext cx="630302" cy="41549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1050" b="1" dirty="0" smtClean="0">
                  <a:latin typeface="Times New Roman" pitchFamily="18" charset="0"/>
                  <a:cs typeface="Times New Roman" pitchFamily="18" charset="0"/>
                </a:rPr>
                <a:t>Exon </a:t>
              </a:r>
            </a:p>
            <a:p>
              <a:pPr algn="r"/>
              <a:r>
                <a:rPr lang="en-US" sz="1050" b="1" dirty="0" smtClean="0">
                  <a:latin typeface="Times New Roman" pitchFamily="18" charset="0"/>
                  <a:cs typeface="Times New Roman" pitchFamily="18" charset="0"/>
                </a:rPr>
                <a:t>/ Intron</a:t>
              </a:r>
            </a:p>
          </p:txBody>
        </p:sp>
        <p:cxnSp>
          <p:nvCxnSpPr>
            <p:cNvPr id="32" name="Straight Arrow Connector 31"/>
            <p:cNvCxnSpPr/>
            <p:nvPr/>
          </p:nvCxnSpPr>
          <p:spPr>
            <a:xfrm>
              <a:off x="786774" y="2759341"/>
              <a:ext cx="182880" cy="0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stealt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8" name="Group 7"/>
          <p:cNvGrpSpPr/>
          <p:nvPr/>
        </p:nvGrpSpPr>
        <p:grpSpPr>
          <a:xfrm>
            <a:off x="4613851" y="457200"/>
            <a:ext cx="4440301" cy="2743200"/>
            <a:chOff x="4613851" y="457200"/>
            <a:chExt cx="4440301" cy="2743200"/>
          </a:xfrm>
        </p:grpSpPr>
        <p:grpSp>
          <p:nvGrpSpPr>
            <p:cNvPr id="26" name="Group 25"/>
            <p:cNvGrpSpPr/>
            <p:nvPr/>
          </p:nvGrpSpPr>
          <p:grpSpPr>
            <a:xfrm>
              <a:off x="4756472" y="457200"/>
              <a:ext cx="4297680" cy="2743200"/>
              <a:chOff x="4473850" y="457200"/>
              <a:chExt cx="4297680" cy="2743200"/>
            </a:xfrm>
          </p:grpSpPr>
          <p:graphicFrame>
            <p:nvGraphicFramePr>
              <p:cNvPr id="6" name="Chart 5"/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3800572902"/>
                  </p:ext>
                </p:extLst>
              </p:nvPr>
            </p:nvGraphicFramePr>
            <p:xfrm>
              <a:off x="4473850" y="457200"/>
              <a:ext cx="4297680" cy="2743200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4"/>
              </a:graphicData>
            </a:graphic>
          </p:graphicFrame>
          <p:sp>
            <p:nvSpPr>
              <p:cNvPr id="24" name="Left Bracket 23"/>
              <p:cNvSpPr/>
              <p:nvPr/>
            </p:nvSpPr>
            <p:spPr>
              <a:xfrm rot="5400000">
                <a:off x="5206848" y="2316480"/>
                <a:ext cx="45720" cy="137160"/>
              </a:xfrm>
              <a:prstGeom prst="leftBracket">
                <a:avLst/>
              </a:prstGeom>
              <a:ln>
                <a:solidFill>
                  <a:schemeClr val="accent3">
                    <a:lumMod val="50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IN"/>
              </a:p>
            </p:txBody>
          </p:sp>
        </p:grpSp>
        <p:sp>
          <p:nvSpPr>
            <p:cNvPr id="31" name="TextBox 30"/>
            <p:cNvSpPr txBox="1"/>
            <p:nvPr/>
          </p:nvSpPr>
          <p:spPr>
            <a:xfrm>
              <a:off x="4613851" y="2563504"/>
              <a:ext cx="630301" cy="41549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1050" b="1" dirty="0" smtClean="0">
                  <a:latin typeface="Times New Roman" pitchFamily="18" charset="0"/>
                  <a:cs typeface="Times New Roman" pitchFamily="18" charset="0"/>
                </a:rPr>
                <a:t>Exon </a:t>
              </a:r>
            </a:p>
            <a:p>
              <a:pPr algn="r"/>
              <a:r>
                <a:rPr lang="en-US" sz="1050" b="1" dirty="0" smtClean="0">
                  <a:latin typeface="Times New Roman" pitchFamily="18" charset="0"/>
                  <a:cs typeface="Times New Roman" pitchFamily="18" charset="0"/>
                </a:rPr>
                <a:t>/ Intron</a:t>
              </a:r>
            </a:p>
          </p:txBody>
        </p:sp>
        <p:cxnSp>
          <p:nvCxnSpPr>
            <p:cNvPr id="33" name="Straight Arrow Connector 32"/>
            <p:cNvCxnSpPr/>
            <p:nvPr/>
          </p:nvCxnSpPr>
          <p:spPr>
            <a:xfrm>
              <a:off x="5200024" y="2751160"/>
              <a:ext cx="182880" cy="0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stealt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173096363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Oval 1"/>
          <p:cNvSpPr/>
          <p:nvPr/>
        </p:nvSpPr>
        <p:spPr>
          <a:xfrm>
            <a:off x="2436808" y="152400"/>
            <a:ext cx="1371600" cy="685800"/>
          </a:xfrm>
          <a:prstGeom prst="ellipse">
            <a:avLst/>
          </a:prstGeom>
          <a:solidFill>
            <a:schemeClr val="accent3">
              <a:lumMod val="60000"/>
              <a:lumOff val="40000"/>
            </a:schemeClr>
          </a:solidFill>
          <a:ln>
            <a:solidFill>
              <a:srgbClr val="00B05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400" b="1" dirty="0" smtClean="0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rPr>
              <a:t>TF entries n=1831</a:t>
            </a:r>
            <a:endParaRPr lang="en-IN" sz="1400" b="1" dirty="0">
              <a:solidFill>
                <a:schemeClr val="tx1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" name="Oval 2"/>
          <p:cNvSpPr/>
          <p:nvPr/>
        </p:nvSpPr>
        <p:spPr>
          <a:xfrm>
            <a:off x="3314128" y="1115704"/>
            <a:ext cx="1828800" cy="822960"/>
          </a:xfrm>
          <a:prstGeom prst="ellipse">
            <a:avLst/>
          </a:prstGeom>
          <a:solidFill>
            <a:schemeClr val="accent3">
              <a:lumMod val="75000"/>
            </a:schemeClr>
          </a:solidFill>
          <a:ln>
            <a:solidFill>
              <a:srgbClr val="00B05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400" b="1" dirty="0" smtClean="0">
                <a:latin typeface="Times New Roman" pitchFamily="18" charset="0"/>
                <a:cs typeface="Times New Roman" pitchFamily="18" charset="0"/>
              </a:rPr>
              <a:t>TF entries</a:t>
            </a:r>
          </a:p>
          <a:p>
            <a:pPr algn="ctr"/>
            <a:r>
              <a:rPr lang="en-US" sz="1400" b="1" dirty="0">
                <a:latin typeface="Times New Roman" pitchFamily="18" charset="0"/>
                <a:cs typeface="Times New Roman" pitchFamily="18" charset="0"/>
              </a:rPr>
              <a:t>D</a:t>
            </a:r>
            <a:r>
              <a:rPr lang="en-US" sz="1400" b="1" dirty="0" smtClean="0">
                <a:latin typeface="Times New Roman" pitchFamily="18" charset="0"/>
                <a:cs typeface="Times New Roman" pitchFamily="18" charset="0"/>
              </a:rPr>
              <a:t>ata available</a:t>
            </a:r>
          </a:p>
          <a:p>
            <a:pPr algn="ctr"/>
            <a:r>
              <a:rPr lang="en-US" sz="1400" b="1" dirty="0" smtClean="0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rPr>
              <a:t>n=970</a:t>
            </a:r>
            <a:endParaRPr lang="en-IN" sz="1400" b="1" dirty="0" smtClean="0">
              <a:solidFill>
                <a:schemeClr val="tx1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" name="Bent Arrow 3"/>
          <p:cNvSpPr/>
          <p:nvPr/>
        </p:nvSpPr>
        <p:spPr>
          <a:xfrm rot="5400000">
            <a:off x="3658031" y="410910"/>
            <a:ext cx="580274" cy="692840"/>
          </a:xfrm>
          <a:prstGeom prst="bentArrow">
            <a:avLst>
              <a:gd name="adj1" fmla="val 5346"/>
              <a:gd name="adj2" fmla="val 14541"/>
              <a:gd name="adj3" fmla="val 29819"/>
              <a:gd name="adj4" fmla="val 26539"/>
            </a:avLst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IN">
              <a:solidFill>
                <a:schemeClr val="tx1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7" name="Oval 6"/>
          <p:cNvSpPr/>
          <p:nvPr/>
        </p:nvSpPr>
        <p:spPr>
          <a:xfrm>
            <a:off x="2789014" y="2362200"/>
            <a:ext cx="2956555" cy="822960"/>
          </a:xfrm>
          <a:prstGeom prst="ellipse">
            <a:avLst/>
          </a:prstGeom>
          <a:solidFill>
            <a:srgbClr val="92D050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dirty="0" smtClean="0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rPr>
              <a:t>TFs significantly, differentially regulated between High and Low p-Akt samples </a:t>
            </a:r>
            <a:r>
              <a:rPr lang="en-US" sz="1200" b="1" dirty="0" smtClean="0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rPr>
              <a:t>n= 48</a:t>
            </a:r>
            <a:endParaRPr lang="en-IN" sz="1200" b="1" dirty="0">
              <a:solidFill>
                <a:schemeClr val="tx1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cxnSp>
        <p:nvCxnSpPr>
          <p:cNvPr id="8" name="Straight Arrow Connector 7"/>
          <p:cNvCxnSpPr/>
          <p:nvPr/>
        </p:nvCxnSpPr>
        <p:spPr>
          <a:xfrm>
            <a:off x="4261168" y="1996440"/>
            <a:ext cx="0" cy="365760"/>
          </a:xfrm>
          <a:prstGeom prst="straightConnector1">
            <a:avLst/>
          </a:prstGeom>
          <a:ln w="38100">
            <a:solidFill>
              <a:schemeClr val="tx1"/>
            </a:solidFill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Oval 8"/>
          <p:cNvSpPr/>
          <p:nvPr/>
        </p:nvSpPr>
        <p:spPr>
          <a:xfrm>
            <a:off x="1206534" y="3520440"/>
            <a:ext cx="2956555" cy="822960"/>
          </a:xfrm>
          <a:prstGeom prst="ellipse">
            <a:avLst/>
          </a:prstGeom>
          <a:solidFill>
            <a:srgbClr val="66FF33"/>
          </a:solidFill>
          <a:ln>
            <a:solidFill>
              <a:srgbClr val="00B05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dirty="0" smtClean="0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rPr>
              <a:t>  TFs with negative differential Log value between High and low p-Akt samples </a:t>
            </a:r>
            <a:r>
              <a:rPr lang="en-US" sz="1200" b="1" dirty="0" smtClean="0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rPr>
              <a:t>n=22</a:t>
            </a:r>
            <a:endParaRPr lang="en-IN" sz="1200" b="1" dirty="0">
              <a:solidFill>
                <a:schemeClr val="tx1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0" name="Oval 9"/>
          <p:cNvSpPr/>
          <p:nvPr/>
        </p:nvSpPr>
        <p:spPr>
          <a:xfrm>
            <a:off x="4381034" y="3520440"/>
            <a:ext cx="2956555" cy="822960"/>
          </a:xfrm>
          <a:prstGeom prst="ellipse">
            <a:avLst/>
          </a:prstGeom>
          <a:solidFill>
            <a:schemeClr val="accent1">
              <a:lumMod val="60000"/>
              <a:lumOff val="40000"/>
            </a:schemeClr>
          </a:solidFill>
          <a:ln>
            <a:solidFill>
              <a:srgbClr val="00B05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dirty="0" smtClean="0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rPr>
              <a:t>TFs with positive differential Log value between High and low p-Akt samples </a:t>
            </a:r>
            <a:r>
              <a:rPr lang="en-US" sz="1200" b="1" dirty="0" smtClean="0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rPr>
              <a:t>n=26</a:t>
            </a:r>
            <a:endParaRPr lang="en-IN" sz="1200" b="1" dirty="0">
              <a:solidFill>
                <a:schemeClr val="tx1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1" name="Oval 10"/>
          <p:cNvSpPr/>
          <p:nvPr/>
        </p:nvSpPr>
        <p:spPr>
          <a:xfrm>
            <a:off x="241479" y="3252908"/>
            <a:ext cx="1554480" cy="731520"/>
          </a:xfrm>
          <a:prstGeom prst="ellipse">
            <a:avLst/>
          </a:prstGeom>
          <a:solidFill>
            <a:schemeClr val="accent3">
              <a:lumMod val="60000"/>
              <a:lumOff val="40000"/>
            </a:schemeClr>
          </a:solidFill>
          <a:ln>
            <a:solidFill>
              <a:schemeClr val="accent3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000" b="1" dirty="0" smtClean="0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rPr>
              <a:t>Putative Transcriptional activators</a:t>
            </a:r>
            <a:endParaRPr lang="en-IN" sz="1000" b="1" dirty="0">
              <a:solidFill>
                <a:schemeClr val="tx1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2" name="Oval 11"/>
          <p:cNvSpPr/>
          <p:nvPr/>
        </p:nvSpPr>
        <p:spPr>
          <a:xfrm>
            <a:off x="6827520" y="3233384"/>
            <a:ext cx="1554480" cy="731520"/>
          </a:xfrm>
          <a:prstGeom prst="ellipse">
            <a:avLst/>
          </a:prstGeom>
          <a:solidFill>
            <a:schemeClr val="tx2">
              <a:lumMod val="20000"/>
              <a:lumOff val="80000"/>
            </a:schemeClr>
          </a:solidFill>
          <a:ln>
            <a:solidFill>
              <a:schemeClr val="accent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000" b="1" dirty="0" smtClean="0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rPr>
              <a:t>Putative</a:t>
            </a:r>
          </a:p>
          <a:p>
            <a:pPr algn="ctr"/>
            <a:r>
              <a:rPr lang="en-US" sz="1000" b="1" dirty="0" smtClean="0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rPr>
              <a:t>Transcriptional repressors</a:t>
            </a:r>
            <a:endParaRPr lang="en-IN" sz="1000" b="1" dirty="0">
              <a:solidFill>
                <a:schemeClr val="tx1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cxnSp>
        <p:nvCxnSpPr>
          <p:cNvPr id="15" name="Straight Arrow Connector 14"/>
          <p:cNvCxnSpPr/>
          <p:nvPr/>
        </p:nvCxnSpPr>
        <p:spPr>
          <a:xfrm rot="16200000" flipH="1">
            <a:off x="4316392" y="3210240"/>
            <a:ext cx="376560" cy="365760"/>
          </a:xfrm>
          <a:prstGeom prst="straightConnector1">
            <a:avLst/>
          </a:prstGeom>
          <a:ln w="38100">
            <a:solidFill>
              <a:schemeClr val="tx1"/>
            </a:solidFill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Straight Arrow Connector 15"/>
          <p:cNvCxnSpPr/>
          <p:nvPr/>
        </p:nvCxnSpPr>
        <p:spPr>
          <a:xfrm flipH="1">
            <a:off x="3878920" y="3204839"/>
            <a:ext cx="376560" cy="365760"/>
          </a:xfrm>
          <a:prstGeom prst="straightConnector1">
            <a:avLst/>
          </a:prstGeom>
          <a:ln w="38100">
            <a:solidFill>
              <a:schemeClr val="tx1"/>
            </a:solidFill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" name="Oval 18"/>
          <p:cNvSpPr/>
          <p:nvPr/>
        </p:nvSpPr>
        <p:spPr>
          <a:xfrm>
            <a:off x="4381034" y="4503760"/>
            <a:ext cx="2956555" cy="822960"/>
          </a:xfrm>
          <a:prstGeom prst="ellipse">
            <a:avLst/>
          </a:prstGeom>
          <a:solidFill>
            <a:schemeClr val="tx2">
              <a:lumMod val="40000"/>
              <a:lumOff val="60000"/>
            </a:schemeClr>
          </a:solidFill>
          <a:ln>
            <a:solidFill>
              <a:srgbClr val="00B05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dirty="0" smtClean="0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rPr>
              <a:t>TFs with binding site on the negative strand </a:t>
            </a:r>
            <a:r>
              <a:rPr lang="en-US" sz="1200" b="1" dirty="0" smtClean="0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rPr>
              <a:t>n=13</a:t>
            </a:r>
            <a:endParaRPr lang="en-IN" sz="1200" b="1" dirty="0">
              <a:solidFill>
                <a:schemeClr val="tx1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0" name="Oval 19"/>
          <p:cNvSpPr/>
          <p:nvPr/>
        </p:nvSpPr>
        <p:spPr>
          <a:xfrm>
            <a:off x="1212221" y="4503760"/>
            <a:ext cx="2956555" cy="822960"/>
          </a:xfrm>
          <a:prstGeom prst="ellipse">
            <a:avLst/>
          </a:prstGeom>
          <a:solidFill>
            <a:srgbClr val="66FF33"/>
          </a:solidFill>
          <a:ln>
            <a:solidFill>
              <a:srgbClr val="00B05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dirty="0" smtClean="0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rPr>
              <a:t>TFs with binding site on the negative strand </a:t>
            </a:r>
            <a:r>
              <a:rPr lang="en-US" sz="1200" b="1" dirty="0" smtClean="0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rPr>
              <a:t>n=12</a:t>
            </a:r>
            <a:endParaRPr lang="en-IN" sz="1200" b="1" dirty="0">
              <a:solidFill>
                <a:schemeClr val="tx1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cxnSp>
        <p:nvCxnSpPr>
          <p:cNvPr id="21" name="Straight Arrow Connector 20"/>
          <p:cNvCxnSpPr/>
          <p:nvPr/>
        </p:nvCxnSpPr>
        <p:spPr>
          <a:xfrm>
            <a:off x="2684811" y="4302456"/>
            <a:ext cx="0" cy="365760"/>
          </a:xfrm>
          <a:prstGeom prst="straightConnector1">
            <a:avLst/>
          </a:prstGeom>
          <a:ln w="38100">
            <a:solidFill>
              <a:schemeClr val="tx1"/>
            </a:solidFill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" name="Straight Arrow Connector 21"/>
          <p:cNvCxnSpPr/>
          <p:nvPr/>
        </p:nvCxnSpPr>
        <p:spPr>
          <a:xfrm>
            <a:off x="5889399" y="4283122"/>
            <a:ext cx="0" cy="365760"/>
          </a:xfrm>
          <a:prstGeom prst="straightConnector1">
            <a:avLst/>
          </a:prstGeom>
          <a:ln w="38100">
            <a:solidFill>
              <a:schemeClr val="tx1"/>
            </a:solidFill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" name="Oval 22"/>
          <p:cNvSpPr/>
          <p:nvPr/>
        </p:nvSpPr>
        <p:spPr>
          <a:xfrm>
            <a:off x="1557664" y="5479349"/>
            <a:ext cx="2286000" cy="457200"/>
          </a:xfrm>
          <a:prstGeom prst="ellipse">
            <a:avLst/>
          </a:prstGeom>
          <a:solidFill>
            <a:srgbClr val="66FF33"/>
          </a:solidFill>
          <a:ln>
            <a:solidFill>
              <a:srgbClr val="00B05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dirty="0" smtClean="0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rPr>
              <a:t>Unique TFs  </a:t>
            </a:r>
            <a:r>
              <a:rPr lang="en-US" sz="1200" b="1" dirty="0" smtClean="0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rPr>
              <a:t>n=4</a:t>
            </a:r>
            <a:endParaRPr lang="en-IN" sz="1200" b="1" dirty="0">
              <a:solidFill>
                <a:schemeClr val="tx1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4" name="Oval 23"/>
          <p:cNvSpPr/>
          <p:nvPr/>
        </p:nvSpPr>
        <p:spPr>
          <a:xfrm>
            <a:off x="4751232" y="5479349"/>
            <a:ext cx="2286000" cy="457200"/>
          </a:xfrm>
          <a:prstGeom prst="ellipse">
            <a:avLst/>
          </a:prstGeom>
          <a:solidFill>
            <a:schemeClr val="tx2">
              <a:lumMod val="40000"/>
              <a:lumOff val="60000"/>
            </a:schemeClr>
          </a:solidFill>
          <a:ln>
            <a:solidFill>
              <a:srgbClr val="00B05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dirty="0" smtClean="0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rPr>
              <a:t>Unique TFs  </a:t>
            </a:r>
            <a:r>
              <a:rPr lang="en-US" sz="1200" b="1" dirty="0" smtClean="0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rPr>
              <a:t>n=7</a:t>
            </a:r>
            <a:endParaRPr lang="en-IN" sz="1200" b="1" dirty="0">
              <a:solidFill>
                <a:schemeClr val="tx1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cxnSp>
        <p:nvCxnSpPr>
          <p:cNvPr id="25" name="Straight Arrow Connector 24"/>
          <p:cNvCxnSpPr/>
          <p:nvPr/>
        </p:nvCxnSpPr>
        <p:spPr>
          <a:xfrm>
            <a:off x="2687083" y="5327632"/>
            <a:ext cx="0" cy="274320"/>
          </a:xfrm>
          <a:prstGeom prst="straightConnector1">
            <a:avLst/>
          </a:prstGeom>
          <a:ln w="38100">
            <a:solidFill>
              <a:schemeClr val="tx1"/>
            </a:solidFill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" name="Straight Arrow Connector 25"/>
          <p:cNvCxnSpPr/>
          <p:nvPr/>
        </p:nvCxnSpPr>
        <p:spPr>
          <a:xfrm>
            <a:off x="5891671" y="5308298"/>
            <a:ext cx="0" cy="274320"/>
          </a:xfrm>
          <a:prstGeom prst="straightConnector1">
            <a:avLst/>
          </a:prstGeom>
          <a:ln w="38100">
            <a:solidFill>
              <a:schemeClr val="tx1"/>
            </a:solidFill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7" name="Oval 26"/>
          <p:cNvSpPr/>
          <p:nvPr/>
        </p:nvSpPr>
        <p:spPr>
          <a:xfrm>
            <a:off x="1557664" y="6095088"/>
            <a:ext cx="2286000" cy="640080"/>
          </a:xfrm>
          <a:prstGeom prst="ellipse">
            <a:avLst/>
          </a:prstGeom>
          <a:solidFill>
            <a:srgbClr val="66FF33"/>
          </a:solidFill>
          <a:ln>
            <a:solidFill>
              <a:srgbClr val="00B05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dirty="0" smtClean="0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rPr>
              <a:t>TFs positively correlating with ARRB1 </a:t>
            </a:r>
            <a:r>
              <a:rPr lang="en-US" sz="1200" b="1" dirty="0" smtClean="0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rPr>
              <a:t>n=1</a:t>
            </a:r>
            <a:endParaRPr lang="en-IN" sz="1200" b="1" dirty="0">
              <a:solidFill>
                <a:schemeClr val="tx1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8" name="Oval 27"/>
          <p:cNvSpPr/>
          <p:nvPr/>
        </p:nvSpPr>
        <p:spPr>
          <a:xfrm>
            <a:off x="4771712" y="6095088"/>
            <a:ext cx="2286000" cy="640080"/>
          </a:xfrm>
          <a:prstGeom prst="ellipse">
            <a:avLst/>
          </a:prstGeom>
          <a:solidFill>
            <a:schemeClr val="tx2">
              <a:lumMod val="40000"/>
              <a:lumOff val="60000"/>
            </a:schemeClr>
          </a:solidFill>
          <a:ln>
            <a:solidFill>
              <a:srgbClr val="00B05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dirty="0" smtClean="0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rPr>
              <a:t>TFs negatively correlating with ARRB1 </a:t>
            </a:r>
            <a:r>
              <a:rPr lang="en-US" sz="1200" b="1" dirty="0" smtClean="0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rPr>
              <a:t>n=3</a:t>
            </a:r>
            <a:endParaRPr lang="en-IN" sz="1200" b="1" dirty="0">
              <a:solidFill>
                <a:schemeClr val="tx1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cxnSp>
        <p:nvCxnSpPr>
          <p:cNvPr id="29" name="Straight Arrow Connector 28"/>
          <p:cNvCxnSpPr/>
          <p:nvPr/>
        </p:nvCxnSpPr>
        <p:spPr>
          <a:xfrm>
            <a:off x="2687083" y="5925176"/>
            <a:ext cx="0" cy="274320"/>
          </a:xfrm>
          <a:prstGeom prst="straightConnector1">
            <a:avLst/>
          </a:prstGeom>
          <a:ln w="38100">
            <a:solidFill>
              <a:schemeClr val="tx1"/>
            </a:solidFill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" name="Straight Arrow Connector 29"/>
          <p:cNvCxnSpPr/>
          <p:nvPr/>
        </p:nvCxnSpPr>
        <p:spPr>
          <a:xfrm>
            <a:off x="5891671" y="5919490"/>
            <a:ext cx="0" cy="274320"/>
          </a:xfrm>
          <a:prstGeom prst="straightConnector1">
            <a:avLst/>
          </a:prstGeom>
          <a:ln w="38100">
            <a:solidFill>
              <a:schemeClr val="tx1"/>
            </a:solidFill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" name="TextBox 12"/>
          <p:cNvSpPr txBox="1"/>
          <p:nvPr/>
        </p:nvSpPr>
        <p:spPr>
          <a:xfrm>
            <a:off x="1270646" y="264467"/>
            <a:ext cx="1102033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>
                <a:latin typeface="Times New Roman" pitchFamily="18" charset="0"/>
                <a:cs typeface="Times New Roman" pitchFamily="18" charset="0"/>
              </a:rPr>
              <a:t>Matinspector </a:t>
            </a:r>
          </a:p>
          <a:p>
            <a:r>
              <a:rPr lang="en-US" sz="1200" b="1" dirty="0" smtClean="0">
                <a:latin typeface="Times New Roman" pitchFamily="18" charset="0"/>
                <a:cs typeface="Times New Roman" pitchFamily="18" charset="0"/>
              </a:rPr>
              <a:t>TF analysis</a:t>
            </a:r>
            <a:endParaRPr lang="en-IN" sz="12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1" name="TextBox 30"/>
          <p:cNvSpPr txBox="1"/>
          <p:nvPr/>
        </p:nvSpPr>
        <p:spPr>
          <a:xfrm>
            <a:off x="7463732" y="-16217"/>
            <a:ext cx="164179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Supplementary figure 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2</a:t>
            </a:r>
            <a:endParaRPr lang="en-IN" sz="12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4" name="Rounded Rectangle 13"/>
          <p:cNvSpPr/>
          <p:nvPr/>
        </p:nvSpPr>
        <p:spPr>
          <a:xfrm>
            <a:off x="4998720" y="1813560"/>
            <a:ext cx="3383280" cy="548640"/>
          </a:xfrm>
          <a:prstGeom prst="roundRect">
            <a:avLst/>
          </a:prstGeom>
          <a:solidFill>
            <a:schemeClr val="accent4">
              <a:lumMod val="60000"/>
              <a:lumOff val="4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400" dirty="0">
                <a:solidFill>
                  <a:sysClr val="windowText" lastClr="000000"/>
                </a:solidFill>
                <a:latin typeface="Times New Roman" pitchFamily="18" charset="0"/>
                <a:cs typeface="Times New Roman" pitchFamily="18" charset="0"/>
              </a:rPr>
              <a:t>p-value significance of differential Log value between High and Low phospho-Akt </a:t>
            </a:r>
            <a:endParaRPr lang="en-IN" sz="1400" dirty="0">
              <a:solidFill>
                <a:sysClr val="windowText" lastClr="000000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2" name="Rounded Rectangle 31"/>
          <p:cNvSpPr/>
          <p:nvPr/>
        </p:nvSpPr>
        <p:spPr>
          <a:xfrm>
            <a:off x="4353324" y="291820"/>
            <a:ext cx="2743200" cy="548640"/>
          </a:xfrm>
          <a:prstGeom prst="roundRect">
            <a:avLst/>
          </a:prstGeom>
          <a:solidFill>
            <a:schemeClr val="accent4">
              <a:lumMod val="60000"/>
              <a:lumOff val="4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400" dirty="0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rPr>
              <a:t>High/Low phospho-Akt samples </a:t>
            </a:r>
            <a:endParaRPr lang="en-US" sz="1400" dirty="0" smtClean="0">
              <a:solidFill>
                <a:schemeClr val="tx1"/>
              </a:solidFill>
              <a:latin typeface="Times New Roman" pitchFamily="18" charset="0"/>
              <a:cs typeface="Times New Roman" pitchFamily="18" charset="0"/>
            </a:endParaRPr>
          </a:p>
          <a:p>
            <a:pPr algn="ctr"/>
            <a:r>
              <a:rPr lang="en-US" sz="1400" dirty="0" smtClean="0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rPr>
              <a:t>in </a:t>
            </a:r>
            <a:r>
              <a:rPr lang="en-US" sz="1400" dirty="0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rPr>
              <a:t>TCGA </a:t>
            </a:r>
            <a:r>
              <a:rPr lang="en-US" sz="1400" dirty="0" smtClean="0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rPr>
              <a:t>RPP array data</a:t>
            </a:r>
            <a:endParaRPr lang="en-IN" sz="1400" dirty="0">
              <a:solidFill>
                <a:schemeClr val="tx1"/>
              </a:solidFill>
              <a:latin typeface="Times New Roman" pitchFamily="18" charset="0"/>
              <a:cs typeface="Times New Roman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57245365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092</TotalTime>
  <Words>146</Words>
  <Application>Microsoft Office PowerPoint</Application>
  <PresentationFormat>On-screen Show (4:3)</PresentationFormat>
  <Paragraphs>44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7" baseType="lpstr">
      <vt:lpstr>Arial</vt:lpstr>
      <vt:lpstr>Calibri</vt:lpstr>
      <vt:lpstr>Times New Roman</vt:lpstr>
      <vt:lpstr>Office Theme</vt:lpstr>
      <vt:lpstr>Supplementary Inform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Nawazahid</dc:creator>
  <cp:lastModifiedBy>Eluna, Jera Mae</cp:lastModifiedBy>
  <cp:revision>19</cp:revision>
  <dcterms:created xsi:type="dcterms:W3CDTF">2016-10-18T18:09:11Z</dcterms:created>
  <dcterms:modified xsi:type="dcterms:W3CDTF">2016-11-15T17:53:05Z</dcterms:modified>
</cp:coreProperties>
</file>